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3" r:id="rId2"/>
    <p:sldId id="281" r:id="rId3"/>
    <p:sldId id="257" r:id="rId4"/>
    <p:sldId id="268" r:id="rId5"/>
    <p:sldId id="262" r:id="rId6"/>
    <p:sldId id="272" r:id="rId7"/>
    <p:sldId id="282" r:id="rId8"/>
    <p:sldId id="284" r:id="rId9"/>
    <p:sldId id="279" r:id="rId10"/>
    <p:sldId id="280" r:id="rId11"/>
  </p:sldIdLst>
  <p:sldSz cx="12192000" cy="6858000"/>
  <p:notesSz cx="6794500" cy="99314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4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長坂 京香" userId="3bad454c8dc41529" providerId="LiveId" clId="{B0331FC7-28F6-4465-9B2F-50093AC3ED60}"/>
    <pc:docChg chg="undo custSel addSld delSld modSld sldOrd">
      <pc:chgData name="長坂 京香" userId="3bad454c8dc41529" providerId="LiveId" clId="{B0331FC7-28F6-4465-9B2F-50093AC3ED60}" dt="2021-11-19T07:04:26.672" v="77"/>
      <pc:docMkLst>
        <pc:docMk/>
      </pc:docMkLst>
      <pc:sldChg chg="addSp delSp modSp mod">
        <pc:chgData name="長坂 京香" userId="3bad454c8dc41529" providerId="LiveId" clId="{B0331FC7-28F6-4465-9B2F-50093AC3ED60}" dt="2021-11-10T12:46:25.486" v="6" actId="1076"/>
        <pc:sldMkLst>
          <pc:docMk/>
          <pc:sldMk cId="3723566658" sldId="257"/>
        </pc:sldMkLst>
        <pc:picChg chg="del">
          <ac:chgData name="長坂 京香" userId="3bad454c8dc41529" providerId="LiveId" clId="{B0331FC7-28F6-4465-9B2F-50093AC3ED60}" dt="2021-11-10T12:46:05.037" v="4" actId="478"/>
          <ac:picMkLst>
            <pc:docMk/>
            <pc:sldMk cId="3723566658" sldId="257"/>
            <ac:picMk id="3" creationId="{E9A44ACC-35D7-4D55-A29D-4247568FE1F3}"/>
          </ac:picMkLst>
        </pc:picChg>
        <pc:picChg chg="add mod">
          <ac:chgData name="長坂 京香" userId="3bad454c8dc41529" providerId="LiveId" clId="{B0331FC7-28F6-4465-9B2F-50093AC3ED60}" dt="2021-11-10T12:46:25.486" v="6" actId="1076"/>
          <ac:picMkLst>
            <pc:docMk/>
            <pc:sldMk cId="3723566658" sldId="257"/>
            <ac:picMk id="5" creationId="{2DD65288-D30C-4B28-8F6D-3225DC03F3EE}"/>
          </ac:picMkLst>
        </pc:picChg>
      </pc:sldChg>
      <pc:sldChg chg="addSp delSp modSp mod">
        <pc:chgData name="長坂 京香" userId="3bad454c8dc41529" providerId="LiveId" clId="{B0331FC7-28F6-4465-9B2F-50093AC3ED60}" dt="2021-11-19T03:14:07.393" v="68" actId="1076"/>
        <pc:sldMkLst>
          <pc:docMk/>
          <pc:sldMk cId="3694893675" sldId="262"/>
        </pc:sldMkLst>
        <pc:picChg chg="add del mod">
          <ac:chgData name="長坂 京香" userId="3bad454c8dc41529" providerId="LiveId" clId="{B0331FC7-28F6-4465-9B2F-50093AC3ED60}" dt="2021-11-19T03:14:01.923" v="66" actId="478"/>
          <ac:picMkLst>
            <pc:docMk/>
            <pc:sldMk cId="3694893675" sldId="262"/>
            <ac:picMk id="3" creationId="{FCC3E3D1-A464-4B87-AE86-78CFF92B2763}"/>
          </ac:picMkLst>
        </pc:picChg>
        <pc:picChg chg="add mod">
          <ac:chgData name="長坂 京香" userId="3bad454c8dc41529" providerId="LiveId" clId="{B0331FC7-28F6-4465-9B2F-50093AC3ED60}" dt="2021-11-19T03:14:07.393" v="68" actId="1076"/>
          <ac:picMkLst>
            <pc:docMk/>
            <pc:sldMk cId="3694893675" sldId="262"/>
            <ac:picMk id="4" creationId="{C2A79CBE-2288-4C6C-A9C9-EE8FCD79C8B2}"/>
          </ac:picMkLst>
        </pc:picChg>
        <pc:picChg chg="del">
          <ac:chgData name="長坂 京香" userId="3bad454c8dc41529" providerId="LiveId" clId="{B0331FC7-28F6-4465-9B2F-50093AC3ED60}" dt="2021-11-19T03:05:34.501" v="61" actId="478"/>
          <ac:picMkLst>
            <pc:docMk/>
            <pc:sldMk cId="3694893675" sldId="262"/>
            <ac:picMk id="7" creationId="{7AE5C56A-5E0E-4A12-8221-813878588DD2}"/>
          </ac:picMkLst>
        </pc:picChg>
      </pc:sldChg>
      <pc:sldChg chg="modSp del mod">
        <pc:chgData name="長坂 京香" userId="3bad454c8dc41529" providerId="LiveId" clId="{B0331FC7-28F6-4465-9B2F-50093AC3ED60}" dt="2021-11-10T12:50:08.064" v="10" actId="2696"/>
        <pc:sldMkLst>
          <pc:docMk/>
          <pc:sldMk cId="3281345817" sldId="265"/>
        </pc:sldMkLst>
        <pc:spChg chg="mod">
          <ac:chgData name="長坂 京香" userId="3bad454c8dc41529" providerId="LiveId" clId="{B0331FC7-28F6-4465-9B2F-50093AC3ED60}" dt="2021-11-10T12:49:41.876" v="9" actId="20577"/>
          <ac:spMkLst>
            <pc:docMk/>
            <pc:sldMk cId="3281345817" sldId="265"/>
            <ac:spMk id="4" creationId="{528F2793-8448-4778-8937-73B88BE9DE3A}"/>
          </ac:spMkLst>
        </pc:spChg>
      </pc:sldChg>
      <pc:sldChg chg="del">
        <pc:chgData name="長坂 京香" userId="3bad454c8dc41529" providerId="LiveId" clId="{B0331FC7-28F6-4465-9B2F-50093AC3ED60}" dt="2021-11-10T12:49:36.191" v="7" actId="2696"/>
        <pc:sldMkLst>
          <pc:docMk/>
          <pc:sldMk cId="2201234867" sldId="267"/>
        </pc:sldMkLst>
      </pc:sldChg>
      <pc:sldChg chg="del">
        <pc:chgData name="長坂 京香" userId="3bad454c8dc41529" providerId="LiveId" clId="{B0331FC7-28F6-4465-9B2F-50093AC3ED60}" dt="2021-11-10T23:01:50.904" v="29" actId="2696"/>
        <pc:sldMkLst>
          <pc:docMk/>
          <pc:sldMk cId="1010793820" sldId="269"/>
        </pc:sldMkLst>
      </pc:sldChg>
      <pc:sldChg chg="addSp delSp modSp mod">
        <pc:chgData name="長坂 京香" userId="3bad454c8dc41529" providerId="LiveId" clId="{B0331FC7-28F6-4465-9B2F-50093AC3ED60}" dt="2021-11-19T07:04:26.672" v="77"/>
        <pc:sldMkLst>
          <pc:docMk/>
          <pc:sldMk cId="2932147514" sldId="271"/>
        </pc:sldMkLst>
        <pc:spChg chg="mod">
          <ac:chgData name="長坂 京香" userId="3bad454c8dc41529" providerId="LiveId" clId="{B0331FC7-28F6-4465-9B2F-50093AC3ED60}" dt="2021-11-18T12:11:24.485" v="50" actId="20577"/>
          <ac:spMkLst>
            <pc:docMk/>
            <pc:sldMk cId="2932147514" sldId="271"/>
            <ac:spMk id="8" creationId="{00CF5475-27A9-4679-9EA1-26B2D9F14CE5}"/>
          </ac:spMkLst>
        </pc:spChg>
        <pc:picChg chg="add del mod">
          <ac:chgData name="長坂 京香" userId="3bad454c8dc41529" providerId="LiveId" clId="{B0331FC7-28F6-4465-9B2F-50093AC3ED60}" dt="2021-11-19T03:07:35.971" v="64" actId="478"/>
          <ac:picMkLst>
            <pc:docMk/>
            <pc:sldMk cId="2932147514" sldId="271"/>
            <ac:picMk id="3" creationId="{1856315E-46D5-4188-B522-B8F59D9DB74A}"/>
          </ac:picMkLst>
        </pc:picChg>
        <pc:picChg chg="add mod">
          <ac:chgData name="長坂 京香" userId="3bad454c8dc41529" providerId="LiveId" clId="{B0331FC7-28F6-4465-9B2F-50093AC3ED60}" dt="2021-11-19T07:04:26.672" v="77"/>
          <ac:picMkLst>
            <pc:docMk/>
            <pc:sldMk cId="2932147514" sldId="271"/>
            <ac:picMk id="3" creationId="{2973F307-7DB8-4276-A9EB-C086E2B4BD08}"/>
          </ac:picMkLst>
        </pc:picChg>
        <pc:picChg chg="del">
          <ac:chgData name="長坂 京香" userId="3bad454c8dc41529" providerId="LiveId" clId="{B0331FC7-28F6-4465-9B2F-50093AC3ED60}" dt="2021-11-10T13:01:06.500" v="23" actId="478"/>
          <ac:picMkLst>
            <pc:docMk/>
            <pc:sldMk cId="2932147514" sldId="271"/>
            <ac:picMk id="4" creationId="{301D6A29-DC73-485B-866B-7216EAF90742}"/>
          </ac:picMkLst>
        </pc:picChg>
        <pc:picChg chg="add del mod">
          <ac:chgData name="長坂 京香" userId="3bad454c8dc41529" providerId="LiveId" clId="{B0331FC7-28F6-4465-9B2F-50093AC3ED60}" dt="2021-11-19T07:04:09.503" v="76" actId="478"/>
          <ac:picMkLst>
            <pc:docMk/>
            <pc:sldMk cId="2932147514" sldId="271"/>
            <ac:picMk id="4" creationId="{9788DB05-691E-4E72-8EF7-D42FC3BA566A}"/>
          </ac:picMkLst>
        </pc:picChg>
      </pc:sldChg>
      <pc:sldChg chg="modSp mod">
        <pc:chgData name="長坂 京香" userId="3bad454c8dc41529" providerId="LiveId" clId="{B0331FC7-28F6-4465-9B2F-50093AC3ED60}" dt="2021-11-10T23:01:57.225" v="31" actId="20577"/>
        <pc:sldMkLst>
          <pc:docMk/>
          <pc:sldMk cId="1386096661" sldId="272"/>
        </pc:sldMkLst>
        <pc:spChg chg="mod">
          <ac:chgData name="長坂 京香" userId="3bad454c8dc41529" providerId="LiveId" clId="{B0331FC7-28F6-4465-9B2F-50093AC3ED60}" dt="2021-11-10T23:01:57.225" v="31" actId="20577"/>
          <ac:spMkLst>
            <pc:docMk/>
            <pc:sldMk cId="1386096661" sldId="272"/>
            <ac:spMk id="4" creationId="{40383169-87EE-4C1F-BECC-461EC95CE132}"/>
          </ac:spMkLst>
        </pc:spChg>
      </pc:sldChg>
      <pc:sldChg chg="modSp mod">
        <pc:chgData name="長坂 京香" userId="3bad454c8dc41529" providerId="LiveId" clId="{B0331FC7-28F6-4465-9B2F-50093AC3ED60}" dt="2021-11-19T05:08:43.507" v="75" actId="20577"/>
        <pc:sldMkLst>
          <pc:docMk/>
          <pc:sldMk cId="791153659" sldId="273"/>
        </pc:sldMkLst>
        <pc:spChg chg="mod">
          <ac:chgData name="長坂 京香" userId="3bad454c8dc41529" providerId="LiveId" clId="{B0331FC7-28F6-4465-9B2F-50093AC3ED60}" dt="2021-11-19T05:08:43.507" v="75" actId="20577"/>
          <ac:spMkLst>
            <pc:docMk/>
            <pc:sldMk cId="791153659" sldId="273"/>
            <ac:spMk id="4" creationId="{BBBFE114-619A-49B5-A888-8ADE64F0D1ED}"/>
          </ac:spMkLst>
        </pc:spChg>
      </pc:sldChg>
      <pc:sldChg chg="addSp delSp modSp mod">
        <pc:chgData name="長坂 京香" userId="3bad454c8dc41529" providerId="LiveId" clId="{B0331FC7-28F6-4465-9B2F-50093AC3ED60}" dt="2021-11-18T12:11:28.986" v="52" actId="20577"/>
        <pc:sldMkLst>
          <pc:docMk/>
          <pc:sldMk cId="3307196120" sldId="279"/>
        </pc:sldMkLst>
        <pc:spChg chg="mod">
          <ac:chgData name="長坂 京香" userId="3bad454c8dc41529" providerId="LiveId" clId="{B0331FC7-28F6-4465-9B2F-50093AC3ED60}" dt="2021-11-18T12:11:28.986" v="52" actId="20577"/>
          <ac:spMkLst>
            <pc:docMk/>
            <pc:sldMk cId="3307196120" sldId="279"/>
            <ac:spMk id="4" creationId="{0B7E5D04-4FD2-42CB-8872-C361C56336FA}"/>
          </ac:spMkLst>
        </pc:spChg>
        <pc:picChg chg="del">
          <ac:chgData name="長坂 京香" userId="3bad454c8dc41529" providerId="LiveId" clId="{B0331FC7-28F6-4465-9B2F-50093AC3ED60}" dt="2021-11-10T13:04:10.147" v="26" actId="478"/>
          <ac:picMkLst>
            <pc:docMk/>
            <pc:sldMk cId="3307196120" sldId="279"/>
            <ac:picMk id="3" creationId="{CCF357F7-D525-45C4-939B-6FBE87431B71}"/>
          </ac:picMkLst>
        </pc:picChg>
        <pc:picChg chg="add mod">
          <ac:chgData name="長坂 京香" userId="3bad454c8dc41529" providerId="LiveId" clId="{B0331FC7-28F6-4465-9B2F-50093AC3ED60}" dt="2021-11-10T13:04:08.781" v="25"/>
          <ac:picMkLst>
            <pc:docMk/>
            <pc:sldMk cId="3307196120" sldId="279"/>
            <ac:picMk id="5" creationId="{375CA42F-B48E-4E1E-B428-A68F098D8845}"/>
          </ac:picMkLst>
        </pc:picChg>
      </pc:sldChg>
      <pc:sldChg chg="addSp delSp modSp mod">
        <pc:chgData name="長坂 京香" userId="3bad454c8dc41529" providerId="LiveId" clId="{B0331FC7-28F6-4465-9B2F-50093AC3ED60}" dt="2021-11-18T12:11:33.441" v="55" actId="20577"/>
        <pc:sldMkLst>
          <pc:docMk/>
          <pc:sldMk cId="2870863218" sldId="280"/>
        </pc:sldMkLst>
        <pc:spChg chg="mod">
          <ac:chgData name="長坂 京香" userId="3bad454c8dc41529" providerId="LiveId" clId="{B0331FC7-28F6-4465-9B2F-50093AC3ED60}" dt="2021-11-18T12:11:33.441" v="55" actId="20577"/>
          <ac:spMkLst>
            <pc:docMk/>
            <pc:sldMk cId="2870863218" sldId="280"/>
            <ac:spMk id="6" creationId="{E9C04BEA-480A-44A3-B835-DB005236A9E4}"/>
          </ac:spMkLst>
        </pc:spChg>
        <pc:picChg chg="add del mod">
          <ac:chgData name="長坂 京香" userId="3bad454c8dc41529" providerId="LiveId" clId="{B0331FC7-28F6-4465-9B2F-50093AC3ED60}" dt="2021-11-11T12:11:09.340" v="39" actId="478"/>
          <ac:picMkLst>
            <pc:docMk/>
            <pc:sldMk cId="2870863218" sldId="280"/>
            <ac:picMk id="3" creationId="{67DB41B3-0BC0-4439-996B-14DF29D99208}"/>
          </ac:picMkLst>
        </pc:picChg>
        <pc:picChg chg="add mod">
          <ac:chgData name="長坂 京香" userId="3bad454c8dc41529" providerId="LiveId" clId="{B0331FC7-28F6-4465-9B2F-50093AC3ED60}" dt="2021-11-11T12:11:11.546" v="40"/>
          <ac:picMkLst>
            <pc:docMk/>
            <pc:sldMk cId="2870863218" sldId="280"/>
            <ac:picMk id="4" creationId="{59A4C229-24DE-460A-B175-0DEDFE6332C9}"/>
          </ac:picMkLst>
        </pc:picChg>
        <pc:picChg chg="del">
          <ac:chgData name="長坂 京香" userId="3bad454c8dc41529" providerId="LiveId" clId="{B0331FC7-28F6-4465-9B2F-50093AC3ED60}" dt="2021-11-10T13:12:36.076" v="27" actId="478"/>
          <ac:picMkLst>
            <pc:docMk/>
            <pc:sldMk cId="2870863218" sldId="280"/>
            <ac:picMk id="4" creationId="{5F3EC4FA-1234-43E3-AD24-314805781525}"/>
          </ac:picMkLst>
        </pc:picChg>
      </pc:sldChg>
      <pc:sldChg chg="addSp delSp modSp mod ord">
        <pc:chgData name="長坂 京香" userId="3bad454c8dc41529" providerId="LiveId" clId="{B0331FC7-28F6-4465-9B2F-50093AC3ED60}" dt="2021-11-19T05:08:39.837" v="73" actId="20577"/>
        <pc:sldMkLst>
          <pc:docMk/>
          <pc:sldMk cId="3727367157" sldId="281"/>
        </pc:sldMkLst>
        <pc:spChg chg="mod">
          <ac:chgData name="長坂 京香" userId="3bad454c8dc41529" providerId="LiveId" clId="{B0331FC7-28F6-4465-9B2F-50093AC3ED60}" dt="2021-11-19T05:08:39.837" v="73" actId="20577"/>
          <ac:spMkLst>
            <pc:docMk/>
            <pc:sldMk cId="3727367157" sldId="281"/>
            <ac:spMk id="4" creationId="{33DFB104-93D2-4C2F-BAB6-FE766A7FB40D}"/>
          </ac:spMkLst>
        </pc:spChg>
        <pc:picChg chg="add mod">
          <ac:chgData name="長坂 京香" userId="3bad454c8dc41529" providerId="LiveId" clId="{B0331FC7-28F6-4465-9B2F-50093AC3ED60}" dt="2021-11-10T12:33:46.266" v="3" actId="14100"/>
          <ac:picMkLst>
            <pc:docMk/>
            <pc:sldMk cId="3727367157" sldId="281"/>
            <ac:picMk id="3" creationId="{7DAA8D86-5B28-485C-A674-B4F206AD6542}"/>
          </ac:picMkLst>
        </pc:picChg>
        <pc:picChg chg="del">
          <ac:chgData name="長坂 京香" userId="3bad454c8dc41529" providerId="LiveId" clId="{B0331FC7-28F6-4465-9B2F-50093AC3ED60}" dt="2021-11-10T12:32:49.182" v="0" actId="478"/>
          <ac:picMkLst>
            <pc:docMk/>
            <pc:sldMk cId="3727367157" sldId="281"/>
            <ac:picMk id="6" creationId="{FCFFC1C3-B0BF-42F2-ADA9-1347500F4B1C}"/>
          </ac:picMkLst>
        </pc:picChg>
      </pc:sldChg>
      <pc:sldChg chg="addSp delSp modSp new mod">
        <pc:chgData name="長坂 京香" userId="3bad454c8dc41529" providerId="LiveId" clId="{B0331FC7-28F6-4465-9B2F-50093AC3ED60}" dt="2021-11-18T13:04:01.064" v="60"/>
        <pc:sldMkLst>
          <pc:docMk/>
          <pc:sldMk cId="3290555930" sldId="282"/>
        </pc:sldMkLst>
        <pc:spChg chg="del">
          <ac:chgData name="長坂 京香" userId="3bad454c8dc41529" providerId="LiveId" clId="{B0331FC7-28F6-4465-9B2F-50093AC3ED60}" dt="2021-11-18T12:11:10.022" v="42" actId="478"/>
          <ac:spMkLst>
            <pc:docMk/>
            <pc:sldMk cId="3290555930" sldId="282"/>
            <ac:spMk id="2" creationId="{C6C835EC-5F2C-488B-B508-73E1CDEB29FA}"/>
          </ac:spMkLst>
        </pc:spChg>
        <pc:spChg chg="del">
          <ac:chgData name="長坂 京香" userId="3bad454c8dc41529" providerId="LiveId" clId="{B0331FC7-28F6-4465-9B2F-50093AC3ED60}" dt="2021-11-18T12:11:11.076" v="43" actId="478"/>
          <ac:spMkLst>
            <pc:docMk/>
            <pc:sldMk cId="3290555930" sldId="282"/>
            <ac:spMk id="3" creationId="{0648FE93-A144-47AD-B289-435DBCF3E1D8}"/>
          </ac:spMkLst>
        </pc:spChg>
        <pc:spChg chg="add mod">
          <ac:chgData name="長坂 京香" userId="3bad454c8dc41529" providerId="LiveId" clId="{B0331FC7-28F6-4465-9B2F-50093AC3ED60}" dt="2021-11-18T12:11:19.796" v="48" actId="20577"/>
          <ac:spMkLst>
            <pc:docMk/>
            <pc:sldMk cId="3290555930" sldId="282"/>
            <ac:spMk id="4" creationId="{1FC52784-B197-473A-9DE4-A524A62C10BF}"/>
          </ac:spMkLst>
        </pc:spChg>
        <pc:picChg chg="add mod">
          <ac:chgData name="長坂 京香" userId="3bad454c8dc41529" providerId="LiveId" clId="{B0331FC7-28F6-4465-9B2F-50093AC3ED60}" dt="2021-11-18T13:04:01.064" v="60"/>
          <ac:picMkLst>
            <pc:docMk/>
            <pc:sldMk cId="3290555930" sldId="282"/>
            <ac:picMk id="3" creationId="{7BAFF271-0206-454E-96B9-59CABB101B9F}"/>
          </ac:picMkLst>
        </pc:picChg>
        <pc:picChg chg="add del mod">
          <ac:chgData name="長坂 京香" userId="3bad454c8dc41529" providerId="LiveId" clId="{B0331FC7-28F6-4465-9B2F-50093AC3ED60}" dt="2021-11-18T12:55:02.444" v="57" actId="478"/>
          <ac:picMkLst>
            <pc:docMk/>
            <pc:sldMk cId="3290555930" sldId="282"/>
            <ac:picMk id="6" creationId="{61BD3920-1156-406D-ACC1-D6B03EAA490E}"/>
          </ac:picMkLst>
        </pc:picChg>
        <pc:picChg chg="add del mod">
          <ac:chgData name="長坂 京香" userId="3bad454c8dc41529" providerId="LiveId" clId="{B0331FC7-28F6-4465-9B2F-50093AC3ED60}" dt="2021-11-18T13:03:47.170" v="59" actId="478"/>
          <ac:picMkLst>
            <pc:docMk/>
            <pc:sldMk cId="3290555930" sldId="282"/>
            <ac:picMk id="8" creationId="{6BE191FD-0156-4265-9AC5-1611D2A9B808}"/>
          </ac:picMkLst>
        </pc:picChg>
      </pc:sldChg>
    </pc:docChg>
  </pc:docChgLst>
  <pc:docChgLst>
    <pc:chgData name="西山 総一郎" userId="6c20cd03b0b25dda" providerId="LiveId" clId="{B58CAD5B-5746-46D7-A88A-12B1A1E660E7}"/>
    <pc:docChg chg="undo custSel addSld delSld modSld">
      <pc:chgData name="西山 総一郎" userId="6c20cd03b0b25dda" providerId="LiveId" clId="{B58CAD5B-5746-46D7-A88A-12B1A1E660E7}" dt="2021-11-19T11:56:13.524" v="10" actId="47"/>
      <pc:docMkLst>
        <pc:docMk/>
      </pc:docMkLst>
      <pc:sldChg chg="add del">
        <pc:chgData name="西山 総一郎" userId="6c20cd03b0b25dda" providerId="LiveId" clId="{B58CAD5B-5746-46D7-A88A-12B1A1E660E7}" dt="2021-11-19T11:56:13.524" v="10" actId="47"/>
        <pc:sldMkLst>
          <pc:docMk/>
          <pc:sldMk cId="2932147514" sldId="271"/>
        </pc:sldMkLst>
      </pc:sldChg>
      <pc:sldChg chg="modSp mod">
        <pc:chgData name="西山 総一郎" userId="6c20cd03b0b25dda" providerId="LiveId" clId="{B58CAD5B-5746-46D7-A88A-12B1A1E660E7}" dt="2021-11-19T10:59:54.175" v="1" actId="1076"/>
        <pc:sldMkLst>
          <pc:docMk/>
          <pc:sldMk cId="791153659" sldId="273"/>
        </pc:sldMkLst>
        <pc:picChg chg="mod">
          <ac:chgData name="西山 総一郎" userId="6c20cd03b0b25dda" providerId="LiveId" clId="{B58CAD5B-5746-46D7-A88A-12B1A1E660E7}" dt="2021-11-19T10:59:54.175" v="1" actId="1076"/>
          <ac:picMkLst>
            <pc:docMk/>
            <pc:sldMk cId="791153659" sldId="273"/>
            <ac:picMk id="5" creationId="{21665F46-38DA-4FED-B1FC-E4925058AEE9}"/>
          </ac:picMkLst>
        </pc:picChg>
      </pc:sldChg>
      <pc:sldChg chg="modSp mod">
        <pc:chgData name="西山 総一郎" userId="6c20cd03b0b25dda" providerId="LiveId" clId="{B58CAD5B-5746-46D7-A88A-12B1A1E660E7}" dt="2021-11-19T10:59:59.052" v="4" actId="1076"/>
        <pc:sldMkLst>
          <pc:docMk/>
          <pc:sldMk cId="3727367157" sldId="281"/>
        </pc:sldMkLst>
        <pc:picChg chg="mod">
          <ac:chgData name="西山 総一郎" userId="6c20cd03b0b25dda" providerId="LiveId" clId="{B58CAD5B-5746-46D7-A88A-12B1A1E660E7}" dt="2021-11-19T10:59:59.052" v="4" actId="1076"/>
          <ac:picMkLst>
            <pc:docMk/>
            <pc:sldMk cId="3727367157" sldId="281"/>
            <ac:picMk id="3" creationId="{7DAA8D86-5B28-485C-A674-B4F206AD6542}"/>
          </ac:picMkLst>
        </pc:picChg>
      </pc:sldChg>
      <pc:sldChg chg="addSp delSp mod">
        <pc:chgData name="西山 総一郎" userId="6c20cd03b0b25dda" providerId="LiveId" clId="{B58CAD5B-5746-46D7-A88A-12B1A1E660E7}" dt="2021-11-19T11:29:24.847" v="6" actId="22"/>
        <pc:sldMkLst>
          <pc:docMk/>
          <pc:sldMk cId="3290555930" sldId="282"/>
        </pc:sldMkLst>
        <pc:spChg chg="add del">
          <ac:chgData name="西山 総一郎" userId="6c20cd03b0b25dda" providerId="LiveId" clId="{B58CAD5B-5746-46D7-A88A-12B1A1E660E7}" dt="2021-11-19T11:29:24.847" v="6" actId="22"/>
          <ac:spMkLst>
            <pc:docMk/>
            <pc:sldMk cId="3290555930" sldId="282"/>
            <ac:spMk id="5" creationId="{1BCBDB97-A0C9-4ECB-9E23-FDC015428AB7}"/>
          </ac:spMkLst>
        </pc:spChg>
      </pc:sldChg>
      <pc:sldChg chg="add">
        <pc:chgData name="西山 総一郎" userId="6c20cd03b0b25dda" providerId="LiveId" clId="{B58CAD5B-5746-46D7-A88A-12B1A1E660E7}" dt="2021-11-19T11:29:28.526" v="7"/>
        <pc:sldMkLst>
          <pc:docMk/>
          <pc:sldMk cId="260558513" sldId="28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CFF025-BF91-4FC9-A8F5-8EE5126D41AD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9100" y="1241425"/>
            <a:ext cx="595630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9486"/>
            <a:ext cx="5435600" cy="3910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8645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1CCEFB-7049-4B5D-98F8-7F04D99B86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1341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8D446D-284F-4756-A7D2-7C3681EADC7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6C19155-0AF2-4748-8BAE-0BEC87DE0B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99E9700-4C13-4ACB-87CD-D0A063E3E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7936B4-020E-4D26-8FCB-020FF7FEB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456C03-E35D-4B2E-9E3D-D896E75F3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0559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D39E9B-36E2-4B57-B571-9C5096E7B2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128F71B-1AAA-46F2-A625-D22AC86998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8483124-C5E6-4A7C-B67A-4E7D7F443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32180D7-50D2-488F-A37A-701B57B57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89E08A3-2112-42DA-A93E-B184306124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9179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3E17EC1-F7A4-41A7-9EB3-883F179705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B28B720-045D-45B3-962F-370BBE9420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9055148-30EB-4D2B-82B8-D8A9849F2A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71654E7-0DA1-4F54-ACA9-82257D9CE2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4EFBC4A-B314-45A0-AA1D-992F317B54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508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D2B506-C52C-4DA2-97FA-0A9CC83EC9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912B835-E7B9-4466-BA31-E9A4A0CE5E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367395E-9625-4691-96EA-B585B688D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2ABA70C-2FDA-4D7C-8996-7373D2753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22C74E-3AFE-422C-A6CE-CB417C840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6146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03A7AE-5254-4AC9-8306-A382D60648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3DFE552-FE30-4F73-AD43-879B8FAFB2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594505-50E9-46B3-BE87-B71A149EE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606CA5-3CBF-4134-99BE-CCA16DEB0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FEB910-1542-43EB-96FA-ADB88D75D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5120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89BF57-D7CE-4FC4-A8B7-9A79D8E98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ECF24FA-9B78-4D01-8349-CBCBE00EAF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A4AA31F-8C1B-4019-ACEB-0ACFC132E3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4C4C4DF-CE82-4C43-B257-B0DF4DD19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3683C3F-F494-4AEF-9E9A-4DD78D57A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CF7842E-1C18-47E5-969B-637E07308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9897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1CACEF-189E-40BD-97C4-82E00BACC9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776C15D-CA00-4E0F-B910-B7CDED36A5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48BD3D4-A9A8-435D-9367-8AAB40D249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508EC37-F9C8-4B36-A223-35D23A5ABC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6DB802D-AAA0-4F1B-B210-1B2EFF18E5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413F3C4-02C4-4218-B71A-72B944348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E99BD70-8D48-4282-8A8C-969CC05B6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E35634C-72C4-4158-B945-A2FCA5D8A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7210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671287-1409-48CF-8462-41AE50DA09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8BDC2FA-3C8F-431F-8CA8-BBDADE85BC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475A4CB-891C-4E03-8A14-8473416EC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9FF8334-4BA1-46A8-AB7D-C3487FDD4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8667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7CBE83C-B9D5-4C18-B881-39AA9CB4F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04FBF85-D485-4871-9070-0D47BBF5B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A7BAE66-DDD1-43AB-9790-FB630216F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1523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CA0EA4-6822-4A49-9A87-0CEA53BEDF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8D3ECA5-765A-4C03-8F6D-F8C16FD8EF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0758726-E049-4467-835B-C9A1A465C5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7B24233-1B62-420E-8638-ED8A3FE46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D616A27-5F63-441B-A451-B2B665AEA6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039FE04-3570-4284-B3D8-33C386403A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243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DEBB43-7010-40B8-99F5-36FFD9736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B30E1DB-4AA2-46C6-8956-B5D46E38CC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845D251-64EF-4C81-BBD0-411E47D93C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D1DC094-8784-4D2F-AD3A-EAE267D76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F5B38A-0534-4717-A0FA-87135BE92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F1F374E-8506-4EBE-879B-AFE1BA6C8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5677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0833C9F-6E1A-4FA0-8988-DD80DACE5B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5A92FEA-A403-4910-A770-81FA4CC281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04ECC1-1FD9-40E7-95A4-0F737636B8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8ADA9-1EBD-4AFF-A683-F4B60C811E0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868C30E-C743-429F-B2D3-2E40A5F93F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057365-4B23-43CD-8481-4C0D504B15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AC529-1F81-49A1-BD10-15990438C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040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BBFE114-619A-49B5-A888-8ADE64F0D1ED}"/>
              </a:ext>
            </a:extLst>
          </p:cNvPr>
          <p:cNvSpPr txBox="1"/>
          <p:nvPr/>
        </p:nvSpPr>
        <p:spPr>
          <a:xfrm>
            <a:off x="1329894" y="458916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21665F46-38DA-4FED-B1FC-E4925058AE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4091" y="2371056"/>
            <a:ext cx="9694581" cy="2573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11536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9C04BEA-480A-44A3-B835-DB005236A9E4}"/>
              </a:ext>
            </a:extLst>
          </p:cNvPr>
          <p:cNvSpPr txBox="1"/>
          <p:nvPr/>
        </p:nvSpPr>
        <p:spPr>
          <a:xfrm>
            <a:off x="1884405" y="290384"/>
            <a:ext cx="2775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9A4C229-24DE-460A-B175-0DEDFE6332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9746" y="1033267"/>
            <a:ext cx="5492507" cy="47914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08632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3DFB104-93D2-4C2F-BAB6-FE766A7FB40D}"/>
              </a:ext>
            </a:extLst>
          </p:cNvPr>
          <p:cNvSpPr txBox="1"/>
          <p:nvPr/>
        </p:nvSpPr>
        <p:spPr>
          <a:xfrm>
            <a:off x="1329894" y="484083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7DAA8D86-5B28-485C-A674-B4F206AD65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8691" y="1210769"/>
            <a:ext cx="8894618" cy="47734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73671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BD1E481-DD65-44EC-8FDF-458CE2AC06B3}"/>
              </a:ext>
            </a:extLst>
          </p:cNvPr>
          <p:cNvSpPr txBox="1"/>
          <p:nvPr/>
        </p:nvSpPr>
        <p:spPr>
          <a:xfrm>
            <a:off x="1177493" y="458916"/>
            <a:ext cx="24400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2DD65288-D30C-4B28-8F6D-3225DC03F3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585" y="0"/>
            <a:ext cx="666179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35666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423ADB6-F296-41DF-A28D-E8786E58F7A9}"/>
              </a:ext>
            </a:extLst>
          </p:cNvPr>
          <p:cNvSpPr txBox="1"/>
          <p:nvPr/>
        </p:nvSpPr>
        <p:spPr>
          <a:xfrm>
            <a:off x="1329894" y="458916"/>
            <a:ext cx="24400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D157B25-6652-4558-9392-307C3859FB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2314" y="1095715"/>
            <a:ext cx="5577851" cy="4242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24104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70D2A85-C065-48A5-A573-BFEE3B53CAA7}"/>
              </a:ext>
            </a:extLst>
          </p:cNvPr>
          <p:cNvSpPr txBox="1"/>
          <p:nvPr/>
        </p:nvSpPr>
        <p:spPr>
          <a:xfrm>
            <a:off x="1305181" y="644268"/>
            <a:ext cx="173316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  <a:p>
            <a:endParaRPr lang="en-US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C2A79CBE-2288-4C6C-A9C9-EE8FCD79C8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8348" y="0"/>
            <a:ext cx="881247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48936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0383169-87EE-4C1F-BECC-461EC95CE132}"/>
              </a:ext>
            </a:extLst>
          </p:cNvPr>
          <p:cNvSpPr txBox="1"/>
          <p:nvPr/>
        </p:nvSpPr>
        <p:spPr>
          <a:xfrm>
            <a:off x="1884405" y="290384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EBA473AF-A55C-4714-8C57-A48A1CD176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5159" y="1046983"/>
            <a:ext cx="8741682" cy="47640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60966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FC52784-B197-473A-9DE4-A524A62C10BF}"/>
              </a:ext>
            </a:extLst>
          </p:cNvPr>
          <p:cNvSpPr txBox="1"/>
          <p:nvPr/>
        </p:nvSpPr>
        <p:spPr>
          <a:xfrm>
            <a:off x="1884405" y="290384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7BAFF271-0206-454E-96B9-59CABB101B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7613" y="2279901"/>
            <a:ext cx="3096774" cy="22981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05559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0CF5475-27A9-4679-9EA1-26B2D9F14CE5}"/>
              </a:ext>
            </a:extLst>
          </p:cNvPr>
          <p:cNvSpPr txBox="1"/>
          <p:nvPr/>
        </p:nvSpPr>
        <p:spPr>
          <a:xfrm>
            <a:off x="2069757" y="636373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634B1C6B-DF81-4632-B82F-F9960845CF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6619" y="999739"/>
            <a:ext cx="8238761" cy="4858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88785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B7E5D04-4FD2-42CB-8872-C361C56336FA}"/>
              </a:ext>
            </a:extLst>
          </p:cNvPr>
          <p:cNvSpPr txBox="1"/>
          <p:nvPr/>
        </p:nvSpPr>
        <p:spPr>
          <a:xfrm>
            <a:off x="2069757" y="636373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375CA42F-B48E-4E1E-B428-A68F098D88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7767" y="2285997"/>
            <a:ext cx="8156465" cy="2286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7196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7</TotalTime>
  <Words>30</Words>
  <Application>Microsoft Office PowerPoint</Application>
  <PresentationFormat>ワイド画面</PresentationFormat>
  <Paragraphs>10</Paragraphs>
  <Slides>10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4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山 総一郎</dc:creator>
  <cp:lastModifiedBy>長坂 京香</cp:lastModifiedBy>
  <cp:revision>9</cp:revision>
  <cp:lastPrinted>2021-12-20T01:08:20Z</cp:lastPrinted>
  <dcterms:created xsi:type="dcterms:W3CDTF">2021-08-23T04:33:13Z</dcterms:created>
  <dcterms:modified xsi:type="dcterms:W3CDTF">2021-12-20T06:55:31Z</dcterms:modified>
</cp:coreProperties>
</file>